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CDC11E-EA77-4745-9B45-22F9AD1320A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ADD255-2980-4BC9-8FBA-ECAB63DD64BC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16A385-BB32-4EB7-B6E3-1A2C392F842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F9E41E-0374-4CAE-9CEB-8FD11310BF1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CCB55-DCFC-4EAC-86EF-29A12D0B28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252F4-274F-4F21-A3FA-B00A10A953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C4E81F-96EF-4138-B4EA-EEC34414B4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F7E30-7F4C-4B77-A27C-20A5EFB08E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A5FD2-AB5C-4A35-AC4B-13D4837EE1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293A4C-3382-4452-BCA5-9979276E5B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2B3D8-2423-49F5-8A8E-C56A145793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65A58B-8EA9-42AD-ABDF-3EE3A835110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6F076-72AC-4562-9AF6-1B11E5A246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B2FD0-766F-42BD-A979-EAC7D70DAC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0BEE714-D139-4CD0-86C8-261563F84FC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2" descr=""/>
          <p:cNvPicPr/>
          <p:nvPr/>
        </p:nvPicPr>
        <p:blipFill>
          <a:blip r:embed="rId1"/>
          <a:stretch/>
        </p:blipFill>
        <p:spPr>
          <a:xfrm>
            <a:off x="157320" y="2239920"/>
            <a:ext cx="6777000" cy="743760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368280" y="566640"/>
            <a:ext cx="595656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File 7 Wheat ESTs aligning to BAC 0006M07 pectinesterase gene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our wheat pectinesterase ESTs are aligned to BAC 006M07 over the matching portion of the genomic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equence. Base differences in the ESTs compared to the BAC sequence are in red. The stop codon i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oxed. This region of the genomic sequence is all within the last two exons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04T23:52:18Z</dcterms:created>
  <dc:creator> </dc:creator>
  <dc:description/>
  <dc:language>en-US</dc:language>
  <cp:lastModifiedBy>Office 2003 Registered User</cp:lastModifiedBy>
  <dcterms:modified xsi:type="dcterms:W3CDTF">2010-05-18T22:42:58Z</dcterms:modified>
  <cp:revision>2</cp:revision>
  <dc:subject/>
  <dc:title>Slide 1</dc:title>
</cp:coreProperties>
</file>